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F26B84-AB4C-4047-9FC1-39B036BBF1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5DC42E2-5F3C-43B6-839F-8E5E7B67BB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8B8F6B0-E440-40F0-8B89-5CB7803F3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66A5FE5-43F2-4884-9224-26A0876E6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A9CDCB-EC21-41B2-B9D4-1CE401293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362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5F09FD-0C8E-49BA-9A0B-9E884D184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2D52D12-9BE9-459A-93A8-FB2C24C21A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4E50091-1E1C-4D78-B240-AFDC733A9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28147A-2712-4289-9106-81179DE94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B0F2DF-46A3-4CBF-94D4-59E4BB343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3193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501A170-FBE8-440A-BF46-A6D53CF539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A288E65-25C7-4152-A4F1-54404E3DCA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74794DA-07F1-4C05-A31B-2C0DAE12D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49A8D9-C104-41B7-91D3-C32DEB258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7CD402-D3D6-4099-B8EA-B62E12045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7546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64C799-2519-4C93-A1DA-E146684C64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117E6DC-79DA-48DC-85C3-4EF1920919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46D513-7E2A-4727-9496-9C4C5C52E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73B413-AE36-4090-8051-F584E0729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5D61476-09E7-4377-AFDC-40C60E921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2678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6982B8-B860-4304-AE26-95CD2D9729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84F71D8-DAB1-49F0-A1B4-76AC12FAEE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08B84A1-76D0-4F6A-BE4F-CA3DC6ACB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E5B106-6138-4DA0-A29A-0F1851876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AEAD01-D338-4FE4-BCD1-54FAF3388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3051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B1AA38-7953-4811-A158-A9E0AC7606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B671C33-7012-46E8-AEA3-B1E1FBDD82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59CAC5E-989C-42EE-AAC5-0F6CD1BB17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23EE7C4-0842-4E76-8AD1-8104060B7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AB20C37-8E97-46E1-A785-82E4A3D3E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D7F395-BCCF-4B5D-909A-709FB5251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167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648977-A34B-4494-9AA7-DD21C4DA83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2A69742-E0B9-49C7-AA20-C1A705CDF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1060C10-FD6D-45AC-B066-55EFFA6BAB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A028042-67C0-47A0-B775-0A1B0B83C9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6B949AF-97FE-4B04-8347-6B22EB8624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9E25969-EAF3-45CB-9A91-8D7444CD6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564142D-5DEA-4D3D-AEEE-9F1D93995A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6A24389-471E-4824-A3C3-9B5DA9F3B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9229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D0E424-E9C2-4A83-BD70-C30AE1697A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4765A9A-8CE7-4A47-9EEF-AA191D782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600F9B7-B49A-45C8-81D4-1AE68EFC8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A93AF54-3909-4B2F-826B-97891B58A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3557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5155020-A8B2-4CD3-BDAA-37493C22E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D8BE935-92F6-4900-A5F8-27288826C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EEF5027-7C57-4AD9-8E48-DBE6CC806D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7011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A158AA-4AD4-4C60-90EA-10F2D7E83E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7B778CE-4095-4FDA-8CC6-3CD07172F2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AB040D8-9B49-438F-8AE4-669FB40279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D7D2537-93FE-402C-A632-A4A36EF08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3461F1B-97F9-4761-B220-3B4290D25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F687E65-5C14-438A-8916-3422DF75A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0564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1E6EAD-C86B-4EB5-9250-BAD8A0115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581DC2-E3E0-4709-A3A6-0047D604EC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60ECC5A-76ED-47EE-B346-432FAFAAF9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54C98DA-542D-41AF-B89E-A3769938E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DFB45CF-67D2-49AC-BBD3-2CB6A7802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C178B4-9E39-4967-98FC-47D5FDD9A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361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C4CDC64-D9FA-4FB7-87F8-2B89CAB28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2D8593-6EC5-455D-8537-26CDA3221F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CD689C-0FED-4551-9575-7C4AB6ED5A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B5401-312E-4ECC-BD64-219F2555F2C8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30EABD-99CC-44BF-8834-335CFB6778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BCA39C-2CE3-4E6D-87A8-87A87759AA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D614D8-DF62-4DFF-AA2F-407CC56371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8292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1C1BA08-E1A4-4DFD-B3FE-374CBC547349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4485" y="648091"/>
            <a:ext cx="6463030" cy="446341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86A6D64C-9D8C-4476-8294-408B5C6B8556}"/>
              </a:ext>
            </a:extLst>
          </p:cNvPr>
          <p:cNvSpPr/>
          <p:nvPr/>
        </p:nvSpPr>
        <p:spPr>
          <a:xfrm>
            <a:off x="1270000" y="5471245"/>
            <a:ext cx="96520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tabLst>
                <a:tab pos="6192520" algn="r"/>
              </a:tabLst>
            </a:pPr>
            <a:r>
              <a:rPr lang="en-US" altLang="zh-CN" sz="1400" b="1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. S5</a:t>
            </a:r>
            <a:r>
              <a:rPr lang="en-US" altLang="zh-CN" sz="1400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The original gel image of Figure 5. Lane 1, 6, negative control; Lane 2, 7, protein marker; Lane 3, lysis of cells transformed with pCold-SUMO-SjNR-L; Lane 4, purified rSjNR-L with SUMO tag; Lane 5, purified rSjNR-L; Lane 8, lysis of cells transformed with pCold-SUMO-SjNR-S; Lane 9, purified rSjNR-S with SUMO tag; Lane 10, purified rSjNR-S.</a:t>
            </a:r>
            <a:endParaRPr lang="zh-CN" altLang="zh-CN" sz="1400" kern="10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694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8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3</cp:revision>
  <dcterms:created xsi:type="dcterms:W3CDTF">2023-01-05T09:12:39Z</dcterms:created>
  <dcterms:modified xsi:type="dcterms:W3CDTF">2023-01-05T14:16:33Z</dcterms:modified>
</cp:coreProperties>
</file>